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5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433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63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051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990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44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13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313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480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64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566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D7E90-D2EA-49F5-BCD3-194DA60099B4}" type="datetimeFigureOut">
              <a:rPr lang="en-US" smtClean="0"/>
              <a:t>1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00BC5-6780-441D-8096-24044B8A5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53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1422201" y="709752"/>
            <a:ext cx="9928431" cy="5320658"/>
            <a:chOff x="2920441" y="2159230"/>
            <a:chExt cx="5137945" cy="2665527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6F96BBB2-FBB6-41E5-BF92-68B5FDB4CE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92973" y="2160932"/>
              <a:ext cx="22938" cy="266382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4">
              <a:extLst>
                <a:ext uri="{FF2B5EF4-FFF2-40B4-BE49-F238E27FC236}">
                  <a16:creationId xmlns:a16="http://schemas.microsoft.com/office/drawing/2014/main" id="{8A5507A3-3133-4925-9554-9CB5277B2A70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2920441" y="2478739"/>
              <a:ext cx="2333626" cy="2276475"/>
              <a:chOff x="562" y="764"/>
              <a:chExt cx="1470" cy="1434"/>
            </a:xfrm>
          </p:grpSpPr>
          <p:sp>
            <p:nvSpPr>
              <p:cNvPr id="9" name="Oval 8">
                <a:extLst>
                  <a:ext uri="{FF2B5EF4-FFF2-40B4-BE49-F238E27FC236}">
                    <a16:creationId xmlns:a16="http://schemas.microsoft.com/office/drawing/2014/main" id="{22BA6B08-AE37-4562-A43E-859E9ECC65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2" y="764"/>
                <a:ext cx="1470" cy="1434"/>
              </a:xfrm>
              <a:prstGeom prst="ellipse">
                <a:avLst/>
              </a:pr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10" name="Freeform 9">
                <a:extLst>
                  <a:ext uri="{FF2B5EF4-FFF2-40B4-BE49-F238E27FC236}">
                    <a16:creationId xmlns:a16="http://schemas.microsoft.com/office/drawing/2014/main" id="{0CDD6A85-3A22-437A-A4B2-FCD553F8BF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4" y="1461"/>
                <a:ext cx="926" cy="709"/>
              </a:xfrm>
              <a:custGeom>
                <a:avLst/>
                <a:gdLst>
                  <a:gd name="T0" fmla="*/ 330 w 926"/>
                  <a:gd name="T1" fmla="*/ 124 h 709"/>
                  <a:gd name="T2" fmla="*/ 853 w 926"/>
                  <a:gd name="T3" fmla="*/ 129 h 709"/>
                  <a:gd name="T4" fmla="*/ 596 w 926"/>
                  <a:gd name="T5" fmla="*/ 585 h 709"/>
                  <a:gd name="T6" fmla="*/ 73 w 926"/>
                  <a:gd name="T7" fmla="*/ 579 h 709"/>
                  <a:gd name="T8" fmla="*/ 330 w 926"/>
                  <a:gd name="T9" fmla="*/ 124 h 7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926" h="709">
                    <a:moveTo>
                      <a:pt x="330" y="124"/>
                    </a:moveTo>
                    <a:cubicBezTo>
                      <a:pt x="546" y="0"/>
                      <a:pt x="780" y="2"/>
                      <a:pt x="853" y="129"/>
                    </a:cubicBezTo>
                    <a:cubicBezTo>
                      <a:pt x="926" y="257"/>
                      <a:pt x="811" y="460"/>
                      <a:pt x="596" y="585"/>
                    </a:cubicBezTo>
                    <a:cubicBezTo>
                      <a:pt x="380" y="709"/>
                      <a:pt x="146" y="706"/>
                      <a:pt x="73" y="579"/>
                    </a:cubicBezTo>
                    <a:cubicBezTo>
                      <a:pt x="0" y="451"/>
                      <a:pt x="115" y="248"/>
                      <a:pt x="330" y="124"/>
                    </a:cubicBez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11" name="Freeform 10">
                <a:extLst>
                  <a:ext uri="{FF2B5EF4-FFF2-40B4-BE49-F238E27FC236}">
                    <a16:creationId xmlns:a16="http://schemas.microsoft.com/office/drawing/2014/main" id="{3E214226-D737-411E-8519-A01208D727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6" y="1740"/>
                <a:ext cx="514" cy="414"/>
              </a:xfrm>
              <a:custGeom>
                <a:avLst/>
                <a:gdLst>
                  <a:gd name="T0" fmla="*/ 180 w 514"/>
                  <a:gd name="T1" fmla="*/ 321 h 414"/>
                  <a:gd name="T2" fmla="*/ 42 w 514"/>
                  <a:gd name="T3" fmla="*/ 63 h 414"/>
                  <a:gd name="T4" fmla="*/ 334 w 514"/>
                  <a:gd name="T5" fmla="*/ 93 h 414"/>
                  <a:gd name="T6" fmla="*/ 472 w 514"/>
                  <a:gd name="T7" fmla="*/ 351 h 414"/>
                  <a:gd name="T8" fmla="*/ 180 w 514"/>
                  <a:gd name="T9" fmla="*/ 321 h 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4" h="414">
                    <a:moveTo>
                      <a:pt x="180" y="321"/>
                    </a:moveTo>
                    <a:cubicBezTo>
                      <a:pt x="62" y="242"/>
                      <a:pt x="0" y="126"/>
                      <a:pt x="42" y="63"/>
                    </a:cubicBezTo>
                    <a:cubicBezTo>
                      <a:pt x="85" y="0"/>
                      <a:pt x="215" y="13"/>
                      <a:pt x="334" y="93"/>
                    </a:cubicBezTo>
                    <a:cubicBezTo>
                      <a:pt x="452" y="172"/>
                      <a:pt x="514" y="288"/>
                      <a:pt x="472" y="351"/>
                    </a:cubicBezTo>
                    <a:cubicBezTo>
                      <a:pt x="429" y="414"/>
                      <a:pt x="299" y="401"/>
                      <a:pt x="180" y="321"/>
                    </a:cubicBez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25C9760A-3FFC-410A-8B24-F4C0E9E583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6" y="841"/>
                <a:ext cx="42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otal genes</a:t>
                </a:r>
                <a:endParaRPr kumimoji="0" lang="en-US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D5D07C05-2AC9-46F2-801B-4F0B60D185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" y="978"/>
                <a:ext cx="23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8401</a:t>
                </a:r>
                <a:endParaRPr kumimoji="0" lang="en-US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011E9A3D-8BA2-4B34-899E-270C8E5ADB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4" y="1395"/>
                <a:ext cx="63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gnificant genes</a:t>
                </a:r>
                <a:endParaRPr kumimoji="0" lang="en-US" altLang="en-US" sz="2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EB5579B-7D9E-4145-A21E-42D2A6F133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5" y="1500"/>
                <a:ext cx="609" cy="1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etabolic genes</a:t>
                </a: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2000" dirty="0">
                    <a:solidFill>
                      <a:srgbClr val="000000"/>
                    </a:solidFill>
                  </a:rPr>
                  <a:t>(1498)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89B3B25C-855D-4A3F-A779-A545A053AE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4" y="1954"/>
                <a:ext cx="1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40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BF31EB81-AF5F-42FD-AF2D-5447B37B1B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1" y="1752"/>
                <a:ext cx="18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00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6BBC868C-F13F-4472-8D3A-81A712543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" y="1801"/>
                <a:ext cx="1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58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A732BB45-5297-41C5-812D-B000BA5493AC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762861" y="2517387"/>
              <a:ext cx="2295525" cy="2255838"/>
              <a:chOff x="2359" y="764"/>
              <a:chExt cx="1446" cy="1421"/>
            </a:xfrm>
          </p:grpSpPr>
          <p:sp>
            <p:nvSpPr>
              <p:cNvPr id="20" name="Freeform 19">
                <a:extLst>
                  <a:ext uri="{FF2B5EF4-FFF2-40B4-BE49-F238E27FC236}">
                    <a16:creationId xmlns:a16="http://schemas.microsoft.com/office/drawing/2014/main" id="{377B4DEF-69A9-4EDE-9145-115D0A5ECC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54" y="1371"/>
                <a:ext cx="833" cy="814"/>
              </a:xfrm>
              <a:custGeom>
                <a:avLst/>
                <a:gdLst>
                  <a:gd name="T0" fmla="*/ 224 w 603"/>
                  <a:gd name="T1" fmla="*/ 89 h 446"/>
                  <a:gd name="T2" fmla="*/ 560 w 603"/>
                  <a:gd name="T3" fmla="*/ 75 h 446"/>
                  <a:gd name="T4" fmla="*/ 379 w 603"/>
                  <a:gd name="T5" fmla="*/ 358 h 446"/>
                  <a:gd name="T6" fmla="*/ 43 w 603"/>
                  <a:gd name="T7" fmla="*/ 372 h 446"/>
                  <a:gd name="T8" fmla="*/ 224 w 603"/>
                  <a:gd name="T9" fmla="*/ 89 h 4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603" h="446">
                    <a:moveTo>
                      <a:pt x="224" y="89"/>
                    </a:moveTo>
                    <a:cubicBezTo>
                      <a:pt x="367" y="7"/>
                      <a:pt x="517" y="0"/>
                      <a:pt x="560" y="75"/>
                    </a:cubicBezTo>
                    <a:cubicBezTo>
                      <a:pt x="603" y="149"/>
                      <a:pt x="522" y="275"/>
                      <a:pt x="379" y="358"/>
                    </a:cubicBezTo>
                    <a:cubicBezTo>
                      <a:pt x="236" y="440"/>
                      <a:pt x="86" y="446"/>
                      <a:pt x="43" y="372"/>
                    </a:cubicBezTo>
                    <a:cubicBezTo>
                      <a:pt x="0" y="298"/>
                      <a:pt x="81" y="171"/>
                      <a:pt x="224" y="89"/>
                    </a:cubicBez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21" name="Freeform 20">
                <a:extLst>
                  <a:ext uri="{FF2B5EF4-FFF2-40B4-BE49-F238E27FC236}">
                    <a16:creationId xmlns:a16="http://schemas.microsoft.com/office/drawing/2014/main" id="{C99DAB43-AE8C-4174-A15E-4125B3B23A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2" y="1573"/>
                <a:ext cx="685" cy="608"/>
              </a:xfrm>
              <a:custGeom>
                <a:avLst/>
                <a:gdLst>
                  <a:gd name="T0" fmla="*/ 280 w 764"/>
                  <a:gd name="T1" fmla="*/ 454 h 605"/>
                  <a:gd name="T2" fmla="*/ 56 w 764"/>
                  <a:gd name="T3" fmla="*/ 83 h 605"/>
                  <a:gd name="T4" fmla="*/ 483 w 764"/>
                  <a:gd name="T5" fmla="*/ 151 h 605"/>
                  <a:gd name="T6" fmla="*/ 707 w 764"/>
                  <a:gd name="T7" fmla="*/ 521 h 605"/>
                  <a:gd name="T8" fmla="*/ 280 w 764"/>
                  <a:gd name="T9" fmla="*/ 454 h 6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64" h="605">
                    <a:moveTo>
                      <a:pt x="280" y="454"/>
                    </a:moveTo>
                    <a:cubicBezTo>
                      <a:pt x="100" y="333"/>
                      <a:pt x="0" y="167"/>
                      <a:pt x="56" y="83"/>
                    </a:cubicBezTo>
                    <a:cubicBezTo>
                      <a:pt x="112" y="0"/>
                      <a:pt x="304" y="30"/>
                      <a:pt x="483" y="151"/>
                    </a:cubicBezTo>
                    <a:cubicBezTo>
                      <a:pt x="663" y="272"/>
                      <a:pt x="764" y="437"/>
                      <a:pt x="707" y="521"/>
                    </a:cubicBezTo>
                    <a:cubicBezTo>
                      <a:pt x="651" y="605"/>
                      <a:pt x="460" y="574"/>
                      <a:pt x="280" y="454"/>
                    </a:cubicBez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22" name="Oval 21">
                <a:extLst>
                  <a:ext uri="{FF2B5EF4-FFF2-40B4-BE49-F238E27FC236}">
                    <a16:creationId xmlns:a16="http://schemas.microsoft.com/office/drawing/2014/main" id="{B09BEC1F-B650-4347-8D25-60F68C0765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9" y="764"/>
                <a:ext cx="1446" cy="1411"/>
              </a:xfrm>
              <a:prstGeom prst="ellipse">
                <a:avLst/>
              </a:pr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36321F93-7C34-47BF-B6BA-6F7B2AD938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4" y="836"/>
                <a:ext cx="42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otal genes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0E655BFC-63BC-4F37-8188-D13684BE6D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8" y="974"/>
                <a:ext cx="23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593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3F1E1CF4-B83C-4DC3-BA9D-D4F8932341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0" y="1295"/>
                <a:ext cx="63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gnificant genes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75F33E2D-EDFE-41F2-9033-7981242CF0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6" y="1418"/>
                <a:ext cx="609" cy="1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etabolic genes</a:t>
                </a: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2000" dirty="0">
                    <a:solidFill>
                      <a:srgbClr val="000000"/>
                    </a:solidFill>
                  </a:rPr>
                  <a:t>(1533)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24CF6A1-A3BC-4DF1-9D29-4B9A348DC3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0" y="1948"/>
                <a:ext cx="1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28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71DD16CC-B375-42CA-89F4-3852480FE5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0" y="1659"/>
                <a:ext cx="1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5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CD0D4A71-FF51-4E33-96B1-990B6B9790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7" y="1556"/>
                <a:ext cx="23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216</a:t>
                </a:r>
                <a:endParaRPr kumimoji="0" lang="en-US" altLang="en-US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38D7867-0060-4388-85E0-1CA8F38A5711}"/>
                </a:ext>
              </a:extLst>
            </p:cNvPr>
            <p:cNvSpPr txBox="1"/>
            <p:nvPr/>
          </p:nvSpPr>
          <p:spPr>
            <a:xfrm>
              <a:off x="3473618" y="2159230"/>
              <a:ext cx="1346383" cy="200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MetaCancer study 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91B64A0-154D-40D1-A650-098B5038A0E4}"/>
                </a:ext>
              </a:extLst>
            </p:cNvPr>
            <p:cNvSpPr txBox="1"/>
            <p:nvPr/>
          </p:nvSpPr>
          <p:spPr>
            <a:xfrm>
              <a:off x="6394631" y="2178384"/>
              <a:ext cx="1663755" cy="200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MetaAnalysis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B6FF4EF-BEA2-49E9-A7FE-9F0B79639355}"/>
              </a:ext>
            </a:extLst>
          </p:cNvPr>
          <p:cNvSpPr txBox="1"/>
          <p:nvPr/>
        </p:nvSpPr>
        <p:spPr>
          <a:xfrm>
            <a:off x="1365662" y="201881"/>
            <a:ext cx="1003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S1</a:t>
            </a:r>
          </a:p>
        </p:txBody>
      </p:sp>
    </p:spTree>
    <p:extLst>
      <p:ext uri="{BB962C8B-B14F-4D97-AF65-F5344CB8AC3E}">
        <p14:creationId xmlns:p14="http://schemas.microsoft.com/office/powerpoint/2010/main" val="3563027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esh Kumar Barupal</dc:creator>
  <cp:lastModifiedBy>barupal-pc</cp:lastModifiedBy>
  <cp:revision>2</cp:revision>
  <dcterms:created xsi:type="dcterms:W3CDTF">2018-11-25T20:15:39Z</dcterms:created>
  <dcterms:modified xsi:type="dcterms:W3CDTF">2019-01-08T18:09:16Z</dcterms:modified>
</cp:coreProperties>
</file>